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  <p:sldId id="259" r:id="rId4"/>
    <p:sldId id="260" r:id="rId5"/>
  </p:sldIdLst>
  <p:sldSz cx="9144000" cy="6858000" type="screen4x3"/>
  <p:notesSz cx="6858000" cy="9144000"/>
  <p:defaultTextStyle>
    <a:defPPr>
      <a:defRPr lang="zh-CN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81" d="100"/>
          <a:sy n="81" d="100"/>
        </p:scale>
        <p:origin x="-1856" y="-12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printerSettings" Target="printerSettings/printerSettings1.bin"/><Relationship Id="rId7" Type="http://schemas.openxmlformats.org/officeDocument/2006/relationships/presProps" Target="presProps.xml"/><Relationship Id="rId8" Type="http://schemas.openxmlformats.org/officeDocument/2006/relationships/viewProps" Target="viewProps.xml"/><Relationship Id="rId9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zh-CN" altLang="en-US" smtClean="0"/>
              <a:t>单击此处编辑母版副标题样式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77A9B1-9545-C247-B5C0-DA2A3B52962E}" type="datetimeFigureOut">
              <a:rPr kumimoji="1" lang="zh-CN" altLang="en-US" smtClean="0"/>
              <a:t>2/19/20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9ABBE-39D0-1F4B-9D9F-1373B1BD55A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5357250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77A9B1-9545-C247-B5C0-DA2A3B52962E}" type="datetimeFigureOut">
              <a:rPr kumimoji="1" lang="zh-CN" altLang="en-US" smtClean="0"/>
              <a:t>2/19/20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9ABBE-39D0-1F4B-9D9F-1373B1BD55A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637860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和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77A9B1-9545-C247-B5C0-DA2A3B52962E}" type="datetimeFigureOut">
              <a:rPr kumimoji="1" lang="zh-CN" altLang="en-US" smtClean="0"/>
              <a:t>2/19/20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9ABBE-39D0-1F4B-9D9F-1373B1BD55A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1525061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77A9B1-9545-C247-B5C0-DA2A3B52962E}" type="datetimeFigureOut">
              <a:rPr kumimoji="1" lang="zh-CN" altLang="en-US" smtClean="0"/>
              <a:t>2/19/20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9ABBE-39D0-1F4B-9D9F-1373B1BD55A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9688443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77A9B1-9545-C247-B5C0-DA2A3B52962E}" type="datetimeFigureOut">
              <a:rPr kumimoji="1" lang="zh-CN" altLang="en-US" smtClean="0"/>
              <a:t>2/19/20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9ABBE-39D0-1F4B-9D9F-1373B1BD55A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9508535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项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77A9B1-9545-C247-B5C0-DA2A3B52962E}" type="datetimeFigureOut">
              <a:rPr kumimoji="1" lang="zh-CN" altLang="en-US" smtClean="0"/>
              <a:t>2/19/20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9ABBE-39D0-1F4B-9D9F-1373B1BD55A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9189397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77A9B1-9545-C247-B5C0-DA2A3B52962E}" type="datetimeFigureOut">
              <a:rPr kumimoji="1" lang="zh-CN" altLang="en-US" smtClean="0"/>
              <a:t>2/19/20</a:t>
            </a:fld>
            <a:endParaRPr kumimoji="1"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幻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9ABBE-39D0-1F4B-9D9F-1373B1BD55A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0364887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77A9B1-9545-C247-B5C0-DA2A3B52962E}" type="datetimeFigureOut">
              <a:rPr kumimoji="1" lang="zh-CN" altLang="en-US" smtClean="0"/>
              <a:t>2/19/20</a:t>
            </a:fld>
            <a:endParaRPr kumimoji="1"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幻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9ABBE-39D0-1F4B-9D9F-1373B1BD55A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9414733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77A9B1-9545-C247-B5C0-DA2A3B52962E}" type="datetimeFigureOut">
              <a:rPr kumimoji="1" lang="zh-CN" altLang="en-US" smtClean="0"/>
              <a:t>2/19/20</a:t>
            </a:fld>
            <a:endParaRPr kumimoji="1"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9ABBE-39D0-1F4B-9D9F-1373B1BD55A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7822790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77A9B1-9545-C247-B5C0-DA2A3B52962E}" type="datetimeFigureOut">
              <a:rPr kumimoji="1" lang="zh-CN" altLang="en-US" smtClean="0"/>
              <a:t>2/19/20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9ABBE-39D0-1F4B-9D9F-1373B1BD55A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4215794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77A9B1-9545-C247-B5C0-DA2A3B52962E}" type="datetimeFigureOut">
              <a:rPr kumimoji="1" lang="zh-CN" altLang="en-US" smtClean="0"/>
              <a:t>2/19/20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9ABBE-39D0-1F4B-9D9F-1373B1BD55A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2764701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77A9B1-9545-C247-B5C0-DA2A3B52962E}" type="datetimeFigureOut">
              <a:rPr kumimoji="1" lang="zh-CN" altLang="en-US" smtClean="0"/>
              <a:t>2/19/20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B9ABBE-39D0-1F4B-9D9F-1373B1BD55A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5609615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.JP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.JP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4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proof of ethics committee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79712" y="548680"/>
            <a:ext cx="4437608" cy="5916811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>
            <a:off x="395536" y="188640"/>
            <a:ext cx="28083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b="1" dirty="0" smtClean="0"/>
              <a:t>Fig.S1 Proof of Medical Ethics</a:t>
            </a:r>
            <a:endParaRPr kumimoji="1" lang="zh-CN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35281488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ethics committee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02988" y="1268760"/>
            <a:ext cx="4674371" cy="5460760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395536" y="476672"/>
            <a:ext cx="46085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b="1" dirty="0" smtClean="0"/>
              <a:t>Fig.S2 Approve of Ethics committee  </a:t>
            </a:r>
            <a:endParaRPr kumimoji="1" lang="zh-CN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7684117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informed consent 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21000" y="0"/>
            <a:ext cx="3300413" cy="6858000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0" y="188640"/>
            <a:ext cx="291581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b="1" dirty="0" smtClean="0"/>
              <a:t>Fig.S3 </a:t>
            </a:r>
            <a:r>
              <a:rPr lang="en-US" altLang="zh-CN" sz="1200" b="1" dirty="0" smtClean="0"/>
              <a:t>Biomedicine </a:t>
            </a:r>
            <a:r>
              <a:rPr lang="en-US" altLang="zh-CN" sz="1200" b="1" dirty="0"/>
              <a:t>Research Informed consent form</a:t>
            </a:r>
            <a:r>
              <a:rPr lang="en-US" altLang="zh-CN" sz="1200" dirty="0"/>
              <a:t> </a:t>
            </a:r>
            <a:endParaRPr lang="zh-CN" altLang="en-US" sz="1200" dirty="0"/>
          </a:p>
          <a:p>
            <a:r>
              <a:rPr kumimoji="1" lang="en-US" altLang="zh-CN" sz="1200" b="1" dirty="0" smtClean="0"/>
              <a:t>   </a:t>
            </a:r>
            <a:endParaRPr kumimoji="1" lang="zh-CN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296206936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/>
          <p:cNvSpPr txBox="1"/>
          <p:nvPr/>
        </p:nvSpPr>
        <p:spPr>
          <a:xfrm>
            <a:off x="721173" y="517437"/>
            <a:ext cx="59552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 smtClean="0"/>
              <a:t>Figure.S4</a:t>
            </a:r>
            <a:r>
              <a:rPr kumimoji="1" lang="zh-CN" altLang="en-US" smtClean="0"/>
              <a:t> </a:t>
            </a:r>
            <a:r>
              <a:rPr lang="en-US" altLang="zh-CN" b="1" smtClean="0"/>
              <a:t>Kaplan</a:t>
            </a:r>
            <a:r>
              <a:rPr lang="en-US" altLang="zh-CN" b="1" dirty="0"/>
              <a:t>-Meier survival curve of patients </a:t>
            </a:r>
            <a:r>
              <a:rPr lang="en-US" altLang="zh-CN" b="1"/>
              <a:t>with </a:t>
            </a:r>
            <a:r>
              <a:rPr lang="en-US" altLang="zh-CN" b="1" smtClean="0"/>
              <a:t>NSCLC</a:t>
            </a:r>
            <a:endParaRPr kumimoji="1" lang="zh-CN" altLang="en-US" dirty="0"/>
          </a:p>
        </p:txBody>
      </p:sp>
      <p:pic>
        <p:nvPicPr>
          <p:cNvPr id="2" name="图片 1" descr="fig s4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16112" y="886769"/>
            <a:ext cx="5869617" cy="57176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925855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办公室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办公室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办公室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45</TotalTime>
  <Words>27</Words>
  <Application>Microsoft Macintosh PowerPoint</Application>
  <PresentationFormat>全屏显示(4:3)</PresentationFormat>
  <Paragraphs>5</Paragraphs>
  <Slides>4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5" baseType="lpstr">
      <vt:lpstr>Office 主题</vt:lpstr>
      <vt:lpstr>PowerPoint 演示文稿</vt:lpstr>
      <vt:lpstr>PowerPoint 演示文稿</vt:lpstr>
      <vt:lpstr>PowerPoint 演示文稿</vt:lpstr>
      <vt:lpstr>PowerPoint 演示文稿</vt:lpstr>
    </vt:vector>
  </TitlesOfParts>
  <Company>UPM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Ning Wei</dc:creator>
  <cp:lastModifiedBy>Ning Wei</cp:lastModifiedBy>
  <cp:revision>6</cp:revision>
  <dcterms:created xsi:type="dcterms:W3CDTF">2019-10-17T03:00:31Z</dcterms:created>
  <dcterms:modified xsi:type="dcterms:W3CDTF">2020-02-20T15:27:23Z</dcterms:modified>
</cp:coreProperties>
</file>